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8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140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879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012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640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55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586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020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396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119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969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859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032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2AB5C68-FFC1-501D-6252-88BB868DE8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074" y="126071"/>
            <a:ext cx="6325148" cy="905334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B4D20C0-6716-90DB-DA60-0B74C9C1E6D6}"/>
              </a:ext>
            </a:extLst>
          </p:cNvPr>
          <p:cNvSpPr txBox="1"/>
          <p:nvPr/>
        </p:nvSpPr>
        <p:spPr>
          <a:xfrm>
            <a:off x="341843" y="9253343"/>
            <a:ext cx="62633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erimental treatment, transcriptome and metabolomics data analysis set up.</a:t>
            </a:r>
          </a:p>
        </p:txBody>
      </p:sp>
    </p:spTree>
    <p:extLst>
      <p:ext uri="{BB962C8B-B14F-4D97-AF65-F5344CB8AC3E}">
        <p14:creationId xmlns:p14="http://schemas.microsoft.com/office/powerpoint/2010/main" val="3072013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</TotalTime>
  <Words>1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Mogilicherla Kanakachari</dc:creator>
  <cp:lastModifiedBy>MDPI</cp:lastModifiedBy>
  <cp:revision>3</cp:revision>
  <dcterms:created xsi:type="dcterms:W3CDTF">2024-03-19T11:30:43Z</dcterms:created>
  <dcterms:modified xsi:type="dcterms:W3CDTF">2024-06-01T09:03:43Z</dcterms:modified>
</cp:coreProperties>
</file>